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81" autoAdjust="0"/>
    <p:restoredTop sz="94660"/>
  </p:normalViewPr>
  <p:slideViewPr>
    <p:cSldViewPr snapToGrid="0">
      <p:cViewPr varScale="1">
        <p:scale>
          <a:sx n="41" d="100"/>
          <a:sy n="41" d="100"/>
        </p:scale>
        <p:origin x="3006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37840F-0D64-4B5E-AFCF-32E1CD000DA4}" type="datetimeFigureOut">
              <a:rPr lang="en-US" smtClean="0"/>
              <a:t>5/28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D48737-D3F1-4CAA-B84F-4D9BEABB8D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4617828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37840F-0D64-4B5E-AFCF-32E1CD000DA4}" type="datetimeFigureOut">
              <a:rPr lang="en-US" smtClean="0"/>
              <a:t>5/28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D48737-D3F1-4CAA-B84F-4D9BEABB8D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6003010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37840F-0D64-4B5E-AFCF-32E1CD000DA4}" type="datetimeFigureOut">
              <a:rPr lang="en-US" smtClean="0"/>
              <a:t>5/28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D48737-D3F1-4CAA-B84F-4D9BEABB8D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8297929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37840F-0D64-4B5E-AFCF-32E1CD000DA4}" type="datetimeFigureOut">
              <a:rPr lang="en-US" smtClean="0"/>
              <a:t>5/28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D48737-D3F1-4CAA-B84F-4D9BEABB8D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822802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37840F-0D64-4B5E-AFCF-32E1CD000DA4}" type="datetimeFigureOut">
              <a:rPr lang="en-US" smtClean="0"/>
              <a:t>5/28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D48737-D3F1-4CAA-B84F-4D9BEABB8D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3212708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37840F-0D64-4B5E-AFCF-32E1CD000DA4}" type="datetimeFigureOut">
              <a:rPr lang="en-US" smtClean="0"/>
              <a:t>5/28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D48737-D3F1-4CAA-B84F-4D9BEABB8D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7359358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37840F-0D64-4B5E-AFCF-32E1CD000DA4}" type="datetimeFigureOut">
              <a:rPr lang="en-US" smtClean="0"/>
              <a:t>5/28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D48737-D3F1-4CAA-B84F-4D9BEABB8D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8237214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37840F-0D64-4B5E-AFCF-32E1CD000DA4}" type="datetimeFigureOut">
              <a:rPr lang="en-US" smtClean="0"/>
              <a:t>5/28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D48737-D3F1-4CAA-B84F-4D9BEABB8D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5694343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37840F-0D64-4B5E-AFCF-32E1CD000DA4}" type="datetimeFigureOut">
              <a:rPr lang="en-US" smtClean="0"/>
              <a:t>5/28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D48737-D3F1-4CAA-B84F-4D9BEABB8D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4579047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37840F-0D64-4B5E-AFCF-32E1CD000DA4}" type="datetimeFigureOut">
              <a:rPr lang="en-US" smtClean="0"/>
              <a:t>5/28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D48737-D3F1-4CAA-B84F-4D9BEABB8D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1081861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37840F-0D64-4B5E-AFCF-32E1CD000DA4}" type="datetimeFigureOut">
              <a:rPr lang="en-US" smtClean="0"/>
              <a:t>5/28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D48737-D3F1-4CAA-B84F-4D9BEABB8D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4380715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6937840F-0D64-4B5E-AFCF-32E1CD000DA4}" type="datetimeFigureOut">
              <a:rPr lang="en-US" smtClean="0"/>
              <a:t>5/28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46D48737-D3F1-4CAA-B84F-4D9BEABB8D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9464036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6660055E-1482-5E47-4D72-71BF27C47290}"/>
              </a:ext>
            </a:extLst>
          </p:cNvPr>
          <p:cNvSpPr txBox="1"/>
          <p:nvPr/>
        </p:nvSpPr>
        <p:spPr>
          <a:xfrm>
            <a:off x="586154" y="8557846"/>
            <a:ext cx="5697415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800" b="1" kern="100" dirty="0">
                <a:effectLst/>
                <a:latin typeface="Aptos" panose="020B00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SDS-PAGE analysis of antigens</a:t>
            </a:r>
            <a:r>
              <a:rPr lang="en-US" sz="1800" kern="100" dirty="0">
                <a:effectLst/>
                <a:latin typeface="Aptos" panose="020B00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. Recombinant F1 and V (5μg) were analyzed by SDS-PAGE (stained with Coomassie Blue) to evaluate apparent molecular weight and purity. </a:t>
            </a:r>
          </a:p>
          <a:p>
            <a:endParaRPr lang="en-US" dirty="0"/>
          </a:p>
        </p:txBody>
      </p:sp>
      <p:pic>
        <p:nvPicPr>
          <p:cNvPr id="6" name="Picture 5" descr="A comparison of a dna test&#10;&#10;AI-generated content may be incorrect.">
            <a:extLst>
              <a:ext uri="{FF2B5EF4-FFF2-40B4-BE49-F238E27FC236}">
                <a16:creationId xmlns:a16="http://schemas.microsoft.com/office/drawing/2014/main" id="{B58E472B-C8FF-B5BA-A911-64973293AC1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86154" y="1291353"/>
            <a:ext cx="5509846" cy="644882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9557528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</TotalTime>
  <Words>30</Words>
  <Application>Microsoft Office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Cote, Christopher K CIV USARMY USAMRIID (USA)</dc:creator>
  <cp:lastModifiedBy>Cote, Christopher K CIV USARMY USAMRIID (USA)</cp:lastModifiedBy>
  <cp:revision>1</cp:revision>
  <dcterms:created xsi:type="dcterms:W3CDTF">2025-05-28T19:01:44Z</dcterms:created>
  <dcterms:modified xsi:type="dcterms:W3CDTF">2025-05-28T19:09:31Z</dcterms:modified>
</cp:coreProperties>
</file>